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76" r:id="rId2"/>
  </p:sldIdLst>
  <p:sldSz cx="6858000" cy="9906000" type="A4"/>
  <p:notesSz cx="6781800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D4D4D"/>
    <a:srgbClr val="333333"/>
    <a:srgbClr val="0000FF"/>
    <a:srgbClr val="00FF00"/>
    <a:srgbClr val="0099CC"/>
    <a:srgbClr val="008000"/>
    <a:srgbClr val="99FFCC"/>
    <a:srgbClr val="006600"/>
    <a:srgbClr val="FF00FF"/>
    <a:srgbClr val="33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 autoAdjust="0"/>
    <p:restoredTop sz="98779" autoAdjust="0"/>
  </p:normalViewPr>
  <p:slideViewPr>
    <p:cSldViewPr>
      <p:cViewPr>
        <p:scale>
          <a:sx n="90" d="100"/>
          <a:sy n="90" d="100"/>
        </p:scale>
        <p:origin x="-2100" y="228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878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quarter" idx="1"/>
          </p:nvPr>
        </p:nvSpPr>
        <p:spPr>
          <a:xfrm>
            <a:off x="3841451" y="0"/>
            <a:ext cx="293878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21794B-3248-4A1C-9EE1-611227A9F16C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2"/>
          </p:nvPr>
        </p:nvSpPr>
        <p:spPr>
          <a:xfrm>
            <a:off x="0" y="9428583"/>
            <a:ext cx="293878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3"/>
          </p:nvPr>
        </p:nvSpPr>
        <p:spPr>
          <a:xfrm>
            <a:off x="3841451" y="9428583"/>
            <a:ext cx="293878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81BC17-4275-49C9-A6BB-70FA8B61DD91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618046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314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7242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5593557" y="396701"/>
            <a:ext cx="1735931" cy="845220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85763" y="396701"/>
            <a:ext cx="5093494" cy="845220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8717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3713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9216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85763" y="2311402"/>
            <a:ext cx="3414713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914775" y="2311402"/>
            <a:ext cx="3414713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2229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5041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7999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5173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2714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0597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DCBA29-4F29-49E3-96D3-767DDD4F485B}" type="datetimeFigureOut">
              <a:rPr lang="en-GB" smtClean="0"/>
              <a:pPr/>
              <a:t>05/04/2015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5793E9-A17D-4363-962A-53F9441089F3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68196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CuadroTexto"/>
          <p:cNvSpPr txBox="1"/>
          <p:nvPr/>
        </p:nvSpPr>
        <p:spPr>
          <a:xfrm>
            <a:off x="5085184" y="9253735"/>
            <a:ext cx="8607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smtClean="0"/>
              <a:t>Figure </a:t>
            </a:r>
            <a:r>
              <a:rPr lang="es-ES" sz="1400" b="1" smtClean="0"/>
              <a:t>S1</a:t>
            </a:r>
            <a:endParaRPr lang="es-ES" sz="1400" b="1" dirty="0"/>
          </a:p>
        </p:txBody>
      </p:sp>
      <p:sp>
        <p:nvSpPr>
          <p:cNvPr id="4" name="3 Rectángulo"/>
          <p:cNvSpPr/>
          <p:nvPr/>
        </p:nvSpPr>
        <p:spPr>
          <a:xfrm>
            <a:off x="548680" y="2216696"/>
            <a:ext cx="6048672" cy="43858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9pro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----------APQLAG------------------------------------AAGGGHSL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2pro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SSSSFADSNPIRPVTDRAASTLESAVLGALGRTRHALRFARFAVRYGKSYESAAEVRRRF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6pro 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-------AFFIPSTASSASHTLDHGLDGEALLMLG--RFHGWMAAHGRSYPTVEEKLRRF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pro 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--AAGDEEPLIRQVVG-GADPLDNDLE-----LDS--QFVGFVQRFGKTYRDAEEHAHRL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0pro 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--------------IPMEDKDLESEEA-----LWD--LYERWQSAH-RVRRHHAEKHRRF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6pro 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---------ADMSIVSYGERSEEEVRR----------MYAEWMAEHGSTYNAIGEEERRF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7pro 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----------ARQLAGDEAITVDAAMVS---------RHEKWMAEHGRTYANEEEKARRL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4pro 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-------RNSDFSIVGYSEEDLSSNER-----LVE--LFEKWLAKHQKAYASFEEKLHRF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                           . :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9pro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GIIQKGI--IQTVNNHPNAG---WTAGHNPYLANYTIEQFKHM-----LGVKPTPPGLLA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2pro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RIFSESLEEVRSTNRKGL-P---YRLGINRF-SDMSWEEFQATRLG-------AAQTCSA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6pro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EVYRSNMEFIEAANRDSRMS---YSLGETPF-TDLTHDEFMAMYSSNDDSSEWEEATVIT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pro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 SVFKANLRRARRHQLLDP-S---AEHGVTKF-SDLTPAEFRRTYLG--LKTT--RRSFLR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0pro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GTFKSNAHFIHSHNKRGDHP---YRLHLNRF-GDMDQAEFRATFVGDLRRDTPSKPPSVP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6pro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 EAFRDNLRYIDQHNAAADAGVHSFRLGLNRF-ADLTNEEYRSTYLG--ARTKPDRERKLS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7pro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EVFRANAKLIDSFNSAEDST---HRLATNRF-ADLTDEEFRAARTG--LRRPPAAAAGAG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4pro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 EVFKDNLKHIDKINREVT-S---YWLGLNEF-ADLTHDEFKAAYLG--LDAAPARRGSSR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.       :              . :  :    ::                    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9pro 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G----VRTKTHPRSEQ-----------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2pro 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TLAGNHLMRDAAA--------------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6pro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TRAGPVHEGTAAVEEPPRRTNLNVTAV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pro 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EMAGSAHDAPVLPTDG-----------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0pro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G----FMYAALNVSD------------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6pro 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A-----RYQAADNDE------------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17pro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SGAGGFRYENFSLAD------------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HvPap-4pro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 S----FRYEDVSASD------------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  <a:endParaRPr lang="es-E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90122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87</TotalTime>
  <Words>2</Words>
  <Application>Microsoft Office PowerPoint</Application>
  <PresentationFormat>A4 (210 x 297 mm)</PresentationFormat>
  <Paragraphs>3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CBG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sabel Diaz</dc:creator>
  <cp:lastModifiedBy>Isabel</cp:lastModifiedBy>
  <cp:revision>157</cp:revision>
  <cp:lastPrinted>2014-12-30T17:32:21Z</cp:lastPrinted>
  <dcterms:created xsi:type="dcterms:W3CDTF">2013-08-06T08:18:38Z</dcterms:created>
  <dcterms:modified xsi:type="dcterms:W3CDTF">2015-04-05T20:06:01Z</dcterms:modified>
</cp:coreProperties>
</file>